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50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52584-634C-4171-B125-F6D65F4EDB53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5337E-C15D-478C-8693-9385DD1778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88403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52584-634C-4171-B125-F6D65F4EDB53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5337E-C15D-478C-8693-9385DD1778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71601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52584-634C-4171-B125-F6D65F4EDB53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5337E-C15D-478C-8693-9385DD1778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55685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52584-634C-4171-B125-F6D65F4EDB53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5337E-C15D-478C-8693-9385DD1778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60416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52584-634C-4171-B125-F6D65F4EDB53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5337E-C15D-478C-8693-9385DD1778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95465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52584-634C-4171-B125-F6D65F4EDB53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5337E-C15D-478C-8693-9385DD1778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7010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52584-634C-4171-B125-F6D65F4EDB53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5337E-C15D-478C-8693-9385DD1778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070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52584-634C-4171-B125-F6D65F4EDB53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5337E-C15D-478C-8693-9385DD1778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59270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52584-634C-4171-B125-F6D65F4EDB53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5337E-C15D-478C-8693-9385DD1778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9755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52584-634C-4171-B125-F6D65F4EDB53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5337E-C15D-478C-8693-9385DD1778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0974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52584-634C-4171-B125-F6D65F4EDB53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65337E-C15D-478C-8693-9385DD1778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22793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752584-634C-4171-B125-F6D65F4EDB53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65337E-C15D-478C-8693-9385DD1778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0773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0451" y="0"/>
            <a:ext cx="5291798" cy="6858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8067674" y="828675"/>
            <a:ext cx="3571875" cy="35394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u="sng" dirty="0"/>
              <a:t>Additional File 7 </a:t>
            </a:r>
            <a:r>
              <a:rPr lang="en-GB" sz="1600" dirty="0"/>
              <a:t>Protein interaction networks associated with mouse </a:t>
            </a:r>
            <a:r>
              <a:rPr lang="en-GB" sz="1600" dirty="0" err="1"/>
              <a:t>Sertoli</a:t>
            </a:r>
            <a:r>
              <a:rPr lang="en-GB" sz="1600" dirty="0"/>
              <a:t> cell-specific transcripts using the STRING database. Each circle represents a protein (node) and each line (edge) represents a protein-protein association.  Only nodes which are connected are shown. The line colour and thickness indicate the type of interaction evidence and the strength of data support. A combination score &gt;0.4 was set as the reliability threshold for network construction. The network contains 509 nodes and 501 edges.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35712962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6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er O'Shaughnessy</dc:creator>
  <cp:lastModifiedBy>Peter O'Shaughnessy</cp:lastModifiedBy>
  <cp:revision>2</cp:revision>
  <dcterms:created xsi:type="dcterms:W3CDTF">2017-08-08T12:33:05Z</dcterms:created>
  <dcterms:modified xsi:type="dcterms:W3CDTF">2017-08-08T12:33:57Z</dcterms:modified>
</cp:coreProperties>
</file>